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574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58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C4577E0-8CAE-6259-1E52-123F8D01217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EC78932-30E3-8294-C365-8CEEC774331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D6A3055-85AC-1EE4-D647-3C39CBB21E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AF073-E5F5-4EC5-8033-D3D2F6EBCDF2}" type="datetimeFigureOut">
              <a:rPr lang="zh-CN" altLang="en-US" smtClean="0"/>
              <a:t>2023/1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FAC1C37-A454-7B9F-F9D5-8267A99C26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F935791-6E98-3BD9-BB37-03E12C74E8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D18E5-A89C-4B48-BEBA-3397145BBF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52487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715057F-57D4-B936-D9B1-813374088F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A37B727-C5B8-F13B-9255-3CCCE859B4F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5253238-5449-148C-C3C5-292FBD4BAD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AF073-E5F5-4EC5-8033-D3D2F6EBCDF2}" type="datetimeFigureOut">
              <a:rPr lang="zh-CN" altLang="en-US" smtClean="0"/>
              <a:t>2023/1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9003132-893E-92AA-E00E-6E4A2A8D22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86A37C0-7416-EB58-1B43-6DFA5EA66E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D18E5-A89C-4B48-BEBA-3397145BBF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63258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0DCCD0CA-0867-3B9E-B9DA-794C7B4D6F7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000D83A-40E1-846E-268B-A664F1C9B4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0AAA420-070A-0983-FE8F-60D0CF0D3C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AF073-E5F5-4EC5-8033-D3D2F6EBCDF2}" type="datetimeFigureOut">
              <a:rPr lang="zh-CN" altLang="en-US" smtClean="0"/>
              <a:t>2023/1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4E9EF2B-F870-5B18-E320-D43A97D362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4F5C2C0-E974-06FB-85F2-E9F14610DB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D18E5-A89C-4B48-BEBA-3397145BBF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89933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D631F62-B82F-334D-3DDF-45D92926A9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07ECDE5-EB27-DA52-0FB5-E42B7FEF76E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B05174B-5330-DB5B-D51A-419E9CF7C4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AF073-E5F5-4EC5-8033-D3D2F6EBCDF2}" type="datetimeFigureOut">
              <a:rPr lang="zh-CN" altLang="en-US" smtClean="0"/>
              <a:t>2023/1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19FCD41-F98D-DF17-68BB-1405A462DE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3A91915-CB09-B697-B7E1-42299727DB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D18E5-A89C-4B48-BEBA-3397145BBF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68917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45BCFF7-4ED7-EAD3-BF52-0128494AE7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C5718C4-83E0-A305-D070-6973568B36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BF7B88A-4B0E-8B6C-2A25-03272F42A8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AF073-E5F5-4EC5-8033-D3D2F6EBCDF2}" type="datetimeFigureOut">
              <a:rPr lang="zh-CN" altLang="en-US" smtClean="0"/>
              <a:t>2023/1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2D7F2E9-8BE1-EF37-0D59-BC365EC250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DF944D0-8B06-7D77-A099-34432E1474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D18E5-A89C-4B48-BEBA-3397145BBF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02493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CEC473C-175B-FF8B-609B-8AA197123A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F131858-1DEE-E77A-CCF2-2D1BD4566C9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B378A2C-0094-B56E-112D-8885AA2DF18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5FB080F-F3E2-EC63-55B2-687316DFD7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AF073-E5F5-4EC5-8033-D3D2F6EBCDF2}" type="datetimeFigureOut">
              <a:rPr lang="zh-CN" altLang="en-US" smtClean="0"/>
              <a:t>2023/1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3F8B8E3-5589-60C8-52D5-F3FFCC4D53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F86E760-AE01-01A3-16BD-8C0E97CD9E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D18E5-A89C-4B48-BEBA-3397145BBF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35233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20E62F8-F764-8A99-26FF-E7C6C0C3DB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B5E9FC0-2E48-0366-4416-020B6036C4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13C759F-533D-5280-4B59-29301D13CA9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74B237A9-A647-170A-E40A-4810B5547FF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65EA4430-6F9C-4404-48E9-3E83BC9907F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5AC06679-F211-A6F4-273E-C411E61D44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AF073-E5F5-4EC5-8033-D3D2F6EBCDF2}" type="datetimeFigureOut">
              <a:rPr lang="zh-CN" altLang="en-US" smtClean="0"/>
              <a:t>2023/1/2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90BC470E-86F5-8974-B27F-5431CEB4DB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D03C25FF-EC07-D923-1015-AE3E385BB9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D18E5-A89C-4B48-BEBA-3397145BBF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26434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421BF7B-4519-64D6-2A6C-CD08822896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60FFFE82-247B-221E-451A-E8469DCB55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AF073-E5F5-4EC5-8033-D3D2F6EBCDF2}" type="datetimeFigureOut">
              <a:rPr lang="zh-CN" altLang="en-US" smtClean="0"/>
              <a:t>2023/1/2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0F4BEA22-794E-0719-2C59-F8DF2FBD22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FF9F220E-06A4-EE2B-1001-751091F130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D18E5-A89C-4B48-BEBA-3397145BBF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97737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FCCDEE51-6993-B80B-74A0-EC46A09834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AF073-E5F5-4EC5-8033-D3D2F6EBCDF2}" type="datetimeFigureOut">
              <a:rPr lang="zh-CN" altLang="en-US" smtClean="0"/>
              <a:t>2023/1/2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082FFFAF-68D6-6CCB-327A-35906F02EC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37FB39B-48A2-8D99-9679-6F7F4E31C3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D18E5-A89C-4B48-BEBA-3397145BBF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20314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197A606-6EB1-C23E-B8EF-6CA7FF9416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F735519-1323-2313-7478-F3EA3AF5EB1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B95B2D8-D4AF-5EDC-C372-8ACA09D528E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133C7E1-792A-5925-C1E9-A0B29F9D78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AF073-E5F5-4EC5-8033-D3D2F6EBCDF2}" type="datetimeFigureOut">
              <a:rPr lang="zh-CN" altLang="en-US" smtClean="0"/>
              <a:t>2023/1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96B70EE-0446-0A0A-FFAA-18F0D1AF65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E2D005D-0961-D6EF-9E01-3B0F023BAD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D18E5-A89C-4B48-BEBA-3397145BBF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01988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A0256EC-6A01-2D1E-81A6-26D48AFEA1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DE18EDCB-DC8B-5CE3-C21A-3484E0D9823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194B506-B83B-FB8F-A7F3-F97899EA90E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C4CDF60-2322-DF27-5D83-AB189201AE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AF073-E5F5-4EC5-8033-D3D2F6EBCDF2}" type="datetimeFigureOut">
              <a:rPr lang="zh-CN" altLang="en-US" smtClean="0"/>
              <a:t>2023/1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F8B51FA-518D-BAC4-2480-839FC8595D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60CBB33-1DA3-92DC-8702-0F2C4F1766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D18E5-A89C-4B48-BEBA-3397145BBF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81474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4C4FBC03-31F0-7B2F-5880-FF143FBC55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352ED8F-94ED-4A40-20D2-A4EF0F73D5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D34C6A4-43CF-3BFA-4382-078B42E4AF7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DAF073-E5F5-4EC5-8033-D3D2F6EBCDF2}" type="datetimeFigureOut">
              <a:rPr lang="zh-CN" altLang="en-US" smtClean="0"/>
              <a:t>2023/1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7EBF7F1-6DA9-6C4A-1AF9-0BAFD2AE158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8269869-11B6-32E6-4916-3F7DAA648B2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ED18E5-A89C-4B48-BEBA-3397145BBF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822920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19">
            <a:extLst>
              <a:ext uri="{FF2B5EF4-FFF2-40B4-BE49-F238E27FC236}">
                <a16:creationId xmlns:a16="http://schemas.microsoft.com/office/drawing/2014/main" id="{F517EED5-47B5-3520-E7EB-317395B5427E}"/>
              </a:ext>
            </a:extLst>
          </p:cNvPr>
          <p:cNvGrpSpPr/>
          <p:nvPr/>
        </p:nvGrpSpPr>
        <p:grpSpPr>
          <a:xfrm>
            <a:off x="4488248" y="402651"/>
            <a:ext cx="6113689" cy="501565"/>
            <a:chOff x="2845165" y="4847941"/>
            <a:chExt cx="6113689" cy="501565"/>
          </a:xfrm>
        </p:grpSpPr>
        <p:sp>
          <p:nvSpPr>
            <p:cNvPr id="10" name="文本框 70">
              <a:extLst>
                <a:ext uri="{FF2B5EF4-FFF2-40B4-BE49-F238E27FC236}">
                  <a16:creationId xmlns:a16="http://schemas.microsoft.com/office/drawing/2014/main" id="{56496038-FFB5-4006-DB8B-011EE411648C}"/>
                </a:ext>
              </a:extLst>
            </p:cNvPr>
            <p:cNvSpPr txBox="1"/>
            <p:nvPr/>
          </p:nvSpPr>
          <p:spPr>
            <a:xfrm>
              <a:off x="5998077" y="4926560"/>
              <a:ext cx="58873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Input</a:t>
              </a:r>
            </a:p>
          </p:txBody>
        </p:sp>
        <p:sp>
          <p:nvSpPr>
            <p:cNvPr id="11" name="文本框 71">
              <a:extLst>
                <a:ext uri="{FF2B5EF4-FFF2-40B4-BE49-F238E27FC236}">
                  <a16:creationId xmlns:a16="http://schemas.microsoft.com/office/drawing/2014/main" id="{95B6BD57-3BD0-310E-485B-82F6DF6622F2}"/>
                </a:ext>
              </a:extLst>
            </p:cNvPr>
            <p:cNvSpPr txBox="1"/>
            <p:nvPr/>
          </p:nvSpPr>
          <p:spPr>
            <a:xfrm>
              <a:off x="6473056" y="4945361"/>
              <a:ext cx="6978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CTD</a:t>
              </a:r>
            </a:p>
          </p:txBody>
        </p:sp>
        <p:sp>
          <p:nvSpPr>
            <p:cNvPr id="12" name="文本框 75">
              <a:extLst>
                <a:ext uri="{FF2B5EF4-FFF2-40B4-BE49-F238E27FC236}">
                  <a16:creationId xmlns:a16="http://schemas.microsoft.com/office/drawing/2014/main" id="{2F2FFDF9-E12F-FDE7-C4AC-97AAA566F43A}"/>
                </a:ext>
              </a:extLst>
            </p:cNvPr>
            <p:cNvSpPr txBox="1"/>
            <p:nvPr/>
          </p:nvSpPr>
          <p:spPr>
            <a:xfrm>
              <a:off x="7140886" y="4926559"/>
              <a:ext cx="58873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Input</a:t>
              </a:r>
            </a:p>
          </p:txBody>
        </p:sp>
        <p:cxnSp>
          <p:nvCxnSpPr>
            <p:cNvPr id="14" name="直接连接符 63">
              <a:extLst>
                <a:ext uri="{FF2B5EF4-FFF2-40B4-BE49-F238E27FC236}">
                  <a16:creationId xmlns:a16="http://schemas.microsoft.com/office/drawing/2014/main" id="{54E62AD1-C009-FBAD-1514-309A55AE1B5B}"/>
                </a:ext>
              </a:extLst>
            </p:cNvPr>
            <p:cNvCxnSpPr>
              <a:cxnSpLocks/>
            </p:cNvCxnSpPr>
            <p:nvPr/>
          </p:nvCxnSpPr>
          <p:spPr>
            <a:xfrm>
              <a:off x="2896136" y="5298045"/>
              <a:ext cx="36576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文本框 49">
              <a:extLst>
                <a:ext uri="{FF2B5EF4-FFF2-40B4-BE49-F238E27FC236}">
                  <a16:creationId xmlns:a16="http://schemas.microsoft.com/office/drawing/2014/main" id="{953F947E-B431-E923-7973-7E4712D7AB0E}"/>
                </a:ext>
              </a:extLst>
            </p:cNvPr>
            <p:cNvSpPr txBox="1"/>
            <p:nvPr/>
          </p:nvSpPr>
          <p:spPr>
            <a:xfrm>
              <a:off x="8496183" y="5072507"/>
              <a:ext cx="4626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Ab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cxnSp>
          <p:nvCxnSpPr>
            <p:cNvPr id="16" name="直接连接符 63">
              <a:extLst>
                <a:ext uri="{FF2B5EF4-FFF2-40B4-BE49-F238E27FC236}">
                  <a16:creationId xmlns:a16="http://schemas.microsoft.com/office/drawing/2014/main" id="{CEEE58DB-6B0E-8D11-0809-DBFFAE2DA881}"/>
                </a:ext>
              </a:extLst>
            </p:cNvPr>
            <p:cNvCxnSpPr>
              <a:cxnSpLocks/>
            </p:cNvCxnSpPr>
            <p:nvPr/>
          </p:nvCxnSpPr>
          <p:spPr>
            <a:xfrm>
              <a:off x="8429111" y="5323067"/>
              <a:ext cx="457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文本框 49">
              <a:extLst>
                <a:ext uri="{FF2B5EF4-FFF2-40B4-BE49-F238E27FC236}">
                  <a16:creationId xmlns:a16="http://schemas.microsoft.com/office/drawing/2014/main" id="{597AD7C1-5116-98C6-7F52-05B433FE1FCF}"/>
                </a:ext>
              </a:extLst>
            </p:cNvPr>
            <p:cNvSpPr txBox="1"/>
            <p:nvPr/>
          </p:nvSpPr>
          <p:spPr>
            <a:xfrm>
              <a:off x="2845165" y="5071490"/>
              <a:ext cx="6436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MW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18" name="文本框 76">
              <a:extLst>
                <a:ext uri="{FF2B5EF4-FFF2-40B4-BE49-F238E27FC236}">
                  <a16:creationId xmlns:a16="http://schemas.microsoft.com/office/drawing/2014/main" id="{A4CF01E2-8AB1-6575-8105-38A294F909EF}"/>
                </a:ext>
              </a:extLst>
            </p:cNvPr>
            <p:cNvSpPr txBox="1"/>
            <p:nvPr/>
          </p:nvSpPr>
          <p:spPr>
            <a:xfrm>
              <a:off x="7456203" y="4847941"/>
              <a:ext cx="90801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CTD+</a:t>
              </a:r>
            </a:p>
            <a:p>
              <a:pPr algn="ctr"/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dsDNA</a:t>
              </a:r>
            </a:p>
          </p:txBody>
        </p:sp>
      </p:grpSp>
      <p:sp>
        <p:nvSpPr>
          <p:cNvPr id="38" name="文本框 79">
            <a:extLst>
              <a:ext uri="{FF2B5EF4-FFF2-40B4-BE49-F238E27FC236}">
                <a16:creationId xmlns:a16="http://schemas.microsoft.com/office/drawing/2014/main" id="{DD6C7B0D-06FB-E78A-9A98-730CD840639D}"/>
              </a:ext>
            </a:extLst>
          </p:cNvPr>
          <p:cNvSpPr txBox="1"/>
          <p:nvPr/>
        </p:nvSpPr>
        <p:spPr>
          <a:xfrm>
            <a:off x="10181126" y="1808780"/>
            <a:ext cx="4411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p53</a:t>
            </a:r>
            <a:endParaRPr lang="zh-CN" alt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</p:txBody>
      </p:sp>
      <p:grpSp>
        <p:nvGrpSpPr>
          <p:cNvPr id="39" name="Group 4">
            <a:extLst>
              <a:ext uri="{FF2B5EF4-FFF2-40B4-BE49-F238E27FC236}">
                <a16:creationId xmlns:a16="http://schemas.microsoft.com/office/drawing/2014/main" id="{81328B0C-2554-4CCC-0A78-86A0AAED7757}"/>
              </a:ext>
            </a:extLst>
          </p:cNvPr>
          <p:cNvGrpSpPr/>
          <p:nvPr/>
        </p:nvGrpSpPr>
        <p:grpSpPr>
          <a:xfrm>
            <a:off x="587602" y="162448"/>
            <a:ext cx="3100239" cy="797908"/>
            <a:chOff x="5633053" y="3811976"/>
            <a:chExt cx="3100239" cy="797908"/>
          </a:xfrm>
        </p:grpSpPr>
        <p:grpSp>
          <p:nvGrpSpPr>
            <p:cNvPr id="40" name="Group 5">
              <a:extLst>
                <a:ext uri="{FF2B5EF4-FFF2-40B4-BE49-F238E27FC236}">
                  <a16:creationId xmlns:a16="http://schemas.microsoft.com/office/drawing/2014/main" id="{1940FABA-5CAD-1E05-DD34-FF48ACD02B5A}"/>
                </a:ext>
              </a:extLst>
            </p:cNvPr>
            <p:cNvGrpSpPr/>
            <p:nvPr/>
          </p:nvGrpSpPr>
          <p:grpSpPr>
            <a:xfrm>
              <a:off x="5633053" y="3811976"/>
              <a:ext cx="2633772" cy="797908"/>
              <a:chOff x="6422691" y="4288161"/>
              <a:chExt cx="2633772" cy="797908"/>
            </a:xfrm>
          </p:grpSpPr>
          <p:pic>
            <p:nvPicPr>
              <p:cNvPr id="46" name="图片 68">
                <a:extLst>
                  <a:ext uri="{FF2B5EF4-FFF2-40B4-BE49-F238E27FC236}">
                    <a16:creationId xmlns:a16="http://schemas.microsoft.com/office/drawing/2014/main" id="{01E74A7E-4810-B0D8-DDB0-BD56ED0B75A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colorTemperature colorTemp="5300"/>
                        </a14:imgEffect>
                        <a14:imgEffect>
                          <a14:saturation sat="0"/>
                        </a14:imgEffect>
                        <a14:imgEffect>
                          <a14:brightnessContrast bright="1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1322" t="31649" r="30391" b="64236"/>
              <a:stretch/>
            </p:blipFill>
            <p:spPr>
              <a:xfrm>
                <a:off x="6889366" y="4726542"/>
                <a:ext cx="902521" cy="359527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47" name="图片 69">
                <a:extLst>
                  <a:ext uri="{FF2B5EF4-FFF2-40B4-BE49-F238E27FC236}">
                    <a16:creationId xmlns:a16="http://schemas.microsoft.com/office/drawing/2014/main" id="{19EE3F6B-7BCD-E0E5-9855-6CFF7CAE5F7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colorTemperature colorTemp="5300"/>
                        </a14:imgEffect>
                        <a14:imgEffect>
                          <a14:saturation sat="0"/>
                        </a14:imgEffect>
                        <a14:imgEffect>
                          <a14:brightnessContrast bright="1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9378" t="31565" r="22335" b="64320"/>
              <a:stretch/>
            </p:blipFill>
            <p:spPr>
              <a:xfrm>
                <a:off x="7899211" y="4726542"/>
                <a:ext cx="902521" cy="359527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sp>
            <p:nvSpPr>
              <p:cNvPr id="48" name="文本框 70">
                <a:extLst>
                  <a:ext uri="{FF2B5EF4-FFF2-40B4-BE49-F238E27FC236}">
                    <a16:creationId xmlns:a16="http://schemas.microsoft.com/office/drawing/2014/main" id="{37C8EFF7-DA56-BAF0-38C7-330CC17CBDAA}"/>
                  </a:ext>
                </a:extLst>
              </p:cNvPr>
              <p:cNvSpPr txBox="1"/>
              <p:nvPr/>
            </p:nvSpPr>
            <p:spPr>
              <a:xfrm>
                <a:off x="6798526" y="4360221"/>
                <a:ext cx="58873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latin typeface="Arial" panose="020B0604020202020204" pitchFamily="34" charset="0"/>
                    <a:ea typeface="黑体" panose="02010609060101010101" pitchFamily="49" charset="-122"/>
                    <a:cs typeface="Arial" panose="020B0604020202020204" pitchFamily="34" charset="0"/>
                  </a:rPr>
                  <a:t>Input</a:t>
                </a:r>
              </a:p>
            </p:txBody>
          </p:sp>
          <p:sp>
            <p:nvSpPr>
              <p:cNvPr id="49" name="文本框 71">
                <a:extLst>
                  <a:ext uri="{FF2B5EF4-FFF2-40B4-BE49-F238E27FC236}">
                    <a16:creationId xmlns:a16="http://schemas.microsoft.com/office/drawing/2014/main" id="{328EFD79-8320-C329-CB4C-6C208BE50B89}"/>
                  </a:ext>
                </a:extLst>
              </p:cNvPr>
              <p:cNvSpPr txBox="1"/>
              <p:nvPr/>
            </p:nvSpPr>
            <p:spPr>
              <a:xfrm>
                <a:off x="7210471" y="4362976"/>
                <a:ext cx="69782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latin typeface="Arial" panose="020B0604020202020204" pitchFamily="34" charset="0"/>
                    <a:ea typeface="黑体" panose="02010609060101010101" pitchFamily="49" charset="-122"/>
                    <a:cs typeface="Arial" panose="020B0604020202020204" pitchFamily="34" charset="0"/>
                  </a:rPr>
                  <a:t>CTD</a:t>
                </a:r>
              </a:p>
            </p:txBody>
          </p:sp>
          <p:sp>
            <p:nvSpPr>
              <p:cNvPr id="50" name="文本框 73">
                <a:extLst>
                  <a:ext uri="{FF2B5EF4-FFF2-40B4-BE49-F238E27FC236}">
                    <a16:creationId xmlns:a16="http://schemas.microsoft.com/office/drawing/2014/main" id="{565E1417-4478-1069-B78A-61769EBACCC6}"/>
                  </a:ext>
                </a:extLst>
              </p:cNvPr>
              <p:cNvSpPr txBox="1"/>
              <p:nvPr/>
            </p:nvSpPr>
            <p:spPr>
              <a:xfrm>
                <a:off x="6422691" y="4770718"/>
                <a:ext cx="50852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ea typeface="黑体" panose="02010609060101010101" pitchFamily="49" charset="-122"/>
                    <a:cs typeface="Arial" panose="020B0604020202020204" pitchFamily="34" charset="0"/>
                  </a:rPr>
                  <a:t>p53</a:t>
                </a:r>
                <a:endParaRPr lang="zh-CN" altLang="en-US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51" name="文本框 75">
                <a:extLst>
                  <a:ext uri="{FF2B5EF4-FFF2-40B4-BE49-F238E27FC236}">
                    <a16:creationId xmlns:a16="http://schemas.microsoft.com/office/drawing/2014/main" id="{8BB0D52D-140D-B0D9-2B2E-B439EB07C514}"/>
                  </a:ext>
                </a:extLst>
              </p:cNvPr>
              <p:cNvSpPr txBox="1"/>
              <p:nvPr/>
            </p:nvSpPr>
            <p:spPr>
              <a:xfrm>
                <a:off x="7817073" y="4353503"/>
                <a:ext cx="58873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latin typeface="Arial" panose="020B0604020202020204" pitchFamily="34" charset="0"/>
                    <a:ea typeface="黑体" panose="02010609060101010101" pitchFamily="49" charset="-122"/>
                    <a:cs typeface="Arial" panose="020B0604020202020204" pitchFamily="34" charset="0"/>
                  </a:rPr>
                  <a:t>Input</a:t>
                </a:r>
              </a:p>
            </p:txBody>
          </p:sp>
          <p:sp>
            <p:nvSpPr>
              <p:cNvPr id="52" name="文本框 76">
                <a:extLst>
                  <a:ext uri="{FF2B5EF4-FFF2-40B4-BE49-F238E27FC236}">
                    <a16:creationId xmlns:a16="http://schemas.microsoft.com/office/drawing/2014/main" id="{30C35A35-9E58-92E2-2551-6016BA83F0CF}"/>
                  </a:ext>
                </a:extLst>
              </p:cNvPr>
              <p:cNvSpPr txBox="1"/>
              <p:nvPr/>
            </p:nvSpPr>
            <p:spPr>
              <a:xfrm>
                <a:off x="8148445" y="4288161"/>
                <a:ext cx="908018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latin typeface="Arial" panose="020B0604020202020204" pitchFamily="34" charset="0"/>
                    <a:ea typeface="黑体" panose="02010609060101010101" pitchFamily="49" charset="-122"/>
                    <a:cs typeface="Arial" panose="020B0604020202020204" pitchFamily="34" charset="0"/>
                  </a:rPr>
                  <a:t>CTD+</a:t>
                </a:r>
              </a:p>
              <a:p>
                <a:pPr algn="ctr"/>
                <a:r>
                  <a:rPr lang="en-US" altLang="zh-CN" sz="1200" dirty="0">
                    <a:latin typeface="Arial" panose="020B0604020202020204" pitchFamily="34" charset="0"/>
                    <a:ea typeface="黑体" panose="02010609060101010101" pitchFamily="49" charset="-122"/>
                    <a:cs typeface="Arial" panose="020B0604020202020204" pitchFamily="34" charset="0"/>
                  </a:rPr>
                  <a:t>dsDNA</a:t>
                </a:r>
              </a:p>
            </p:txBody>
          </p:sp>
        </p:grpSp>
        <p:sp>
          <p:nvSpPr>
            <p:cNvPr id="41" name="文本框 35">
              <a:extLst>
                <a:ext uri="{FF2B5EF4-FFF2-40B4-BE49-F238E27FC236}">
                  <a16:creationId xmlns:a16="http://schemas.microsoft.com/office/drawing/2014/main" id="{6BBB29F6-8105-6F37-8D99-1887490AC639}"/>
                </a:ext>
              </a:extLst>
            </p:cNvPr>
            <p:cNvSpPr txBox="1"/>
            <p:nvPr/>
          </p:nvSpPr>
          <p:spPr>
            <a:xfrm>
              <a:off x="7973984" y="4265847"/>
              <a:ext cx="6838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>
                  <a:latin typeface="Arial" panose="020B0604020202020204" pitchFamily="34" charset="0"/>
                  <a:cs typeface="Arial" panose="020B0604020202020204" pitchFamily="34" charset="0"/>
                </a:rPr>
                <a:t>75 </a:t>
              </a:r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2" name="直接连接符 63">
              <a:extLst>
                <a:ext uri="{FF2B5EF4-FFF2-40B4-BE49-F238E27FC236}">
                  <a16:creationId xmlns:a16="http://schemas.microsoft.com/office/drawing/2014/main" id="{C320302A-7617-7578-8CB4-D62F62E0511C}"/>
                </a:ext>
              </a:extLst>
            </p:cNvPr>
            <p:cNvCxnSpPr>
              <a:cxnSpLocks/>
            </p:cNvCxnSpPr>
            <p:nvPr/>
          </p:nvCxnSpPr>
          <p:spPr>
            <a:xfrm>
              <a:off x="5652581" y="4271482"/>
              <a:ext cx="36576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文本框 49">
              <a:extLst>
                <a:ext uri="{FF2B5EF4-FFF2-40B4-BE49-F238E27FC236}">
                  <a16:creationId xmlns:a16="http://schemas.microsoft.com/office/drawing/2014/main" id="{EC0A0C75-2A24-5742-55FB-4C7C62134551}"/>
                </a:ext>
              </a:extLst>
            </p:cNvPr>
            <p:cNvSpPr txBox="1"/>
            <p:nvPr/>
          </p:nvSpPr>
          <p:spPr>
            <a:xfrm>
              <a:off x="5656368" y="4009490"/>
              <a:ext cx="4626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Ab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cxnSp>
          <p:nvCxnSpPr>
            <p:cNvPr id="44" name="直接连接符 63">
              <a:extLst>
                <a:ext uri="{FF2B5EF4-FFF2-40B4-BE49-F238E27FC236}">
                  <a16:creationId xmlns:a16="http://schemas.microsoft.com/office/drawing/2014/main" id="{BD19CF2E-152D-F461-7AE1-E64F82BDC1FC}"/>
                </a:ext>
              </a:extLst>
            </p:cNvPr>
            <p:cNvCxnSpPr>
              <a:cxnSpLocks/>
            </p:cNvCxnSpPr>
            <p:nvPr/>
          </p:nvCxnSpPr>
          <p:spPr>
            <a:xfrm>
              <a:off x="8073701" y="4272807"/>
              <a:ext cx="457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文本框 49">
              <a:extLst>
                <a:ext uri="{FF2B5EF4-FFF2-40B4-BE49-F238E27FC236}">
                  <a16:creationId xmlns:a16="http://schemas.microsoft.com/office/drawing/2014/main" id="{D1EA1521-EE7A-543B-336A-D8B99019E4B3}"/>
                </a:ext>
              </a:extLst>
            </p:cNvPr>
            <p:cNvSpPr txBox="1"/>
            <p:nvPr/>
          </p:nvSpPr>
          <p:spPr>
            <a:xfrm>
              <a:off x="8089603" y="4010816"/>
              <a:ext cx="6436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MW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</p:grpSp>
      <p:pic>
        <p:nvPicPr>
          <p:cNvPr id="54" name="图片 53">
            <a:extLst>
              <a:ext uri="{FF2B5EF4-FFF2-40B4-BE49-F238E27FC236}">
                <a16:creationId xmlns:a16="http://schemas.microsoft.com/office/drawing/2014/main" id="{B25386A4-AB49-A90C-CAA4-F71D1C7CCE9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071" t="22569" r="18902" b="19443"/>
          <a:stretch/>
        </p:blipFill>
        <p:spPr>
          <a:xfrm>
            <a:off x="4928970" y="960356"/>
            <a:ext cx="5197557" cy="5492564"/>
          </a:xfrm>
          <a:prstGeom prst="rect">
            <a:avLst/>
          </a:prstGeom>
        </p:spPr>
      </p:pic>
      <p:sp>
        <p:nvSpPr>
          <p:cNvPr id="55" name="文本框 54">
            <a:extLst>
              <a:ext uri="{FF2B5EF4-FFF2-40B4-BE49-F238E27FC236}">
                <a16:creationId xmlns:a16="http://schemas.microsoft.com/office/drawing/2014/main" id="{ADAF624E-AE6A-2BDA-D147-4897C2BF9F80}"/>
              </a:ext>
            </a:extLst>
          </p:cNvPr>
          <p:cNvSpPr txBox="1"/>
          <p:nvPr/>
        </p:nvSpPr>
        <p:spPr>
          <a:xfrm>
            <a:off x="4293168" y="2944361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BB1FCCA9-C456-F7EB-1685-1FACB30FBD49}"/>
              </a:ext>
            </a:extLst>
          </p:cNvPr>
          <p:cNvSpPr txBox="1"/>
          <p:nvPr/>
        </p:nvSpPr>
        <p:spPr>
          <a:xfrm>
            <a:off x="4293168" y="2481960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7DDC40BB-5B9C-E840-711D-467F198D4A69}"/>
              </a:ext>
            </a:extLst>
          </p:cNvPr>
          <p:cNvSpPr txBox="1"/>
          <p:nvPr/>
        </p:nvSpPr>
        <p:spPr>
          <a:xfrm>
            <a:off x="4293168" y="2124371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A3AC97E3-3A53-83DA-C738-26CD7E74E534}"/>
              </a:ext>
            </a:extLst>
          </p:cNvPr>
          <p:cNvSpPr txBox="1"/>
          <p:nvPr/>
        </p:nvSpPr>
        <p:spPr>
          <a:xfrm>
            <a:off x="4293168" y="3558908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7C496498-A283-9B30-C681-0BE0790F5ECD}"/>
              </a:ext>
            </a:extLst>
          </p:cNvPr>
          <p:cNvSpPr txBox="1"/>
          <p:nvPr/>
        </p:nvSpPr>
        <p:spPr>
          <a:xfrm>
            <a:off x="4293168" y="1806745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9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0E1323A6-BA55-6696-25AA-F9FFDFF9B28F}"/>
              </a:ext>
            </a:extLst>
          </p:cNvPr>
          <p:cNvSpPr txBox="1"/>
          <p:nvPr/>
        </p:nvSpPr>
        <p:spPr>
          <a:xfrm>
            <a:off x="4293168" y="4111999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4900606F-DC2F-0F15-314F-F89E71E0E991}"/>
              </a:ext>
            </a:extLst>
          </p:cNvPr>
          <p:cNvSpPr txBox="1"/>
          <p:nvPr/>
        </p:nvSpPr>
        <p:spPr>
          <a:xfrm>
            <a:off x="4293168" y="1529598"/>
            <a:ext cx="9091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BC4EE9A0-C591-2334-A9EA-FFD8663ED4A1}"/>
              </a:ext>
            </a:extLst>
          </p:cNvPr>
          <p:cNvSpPr txBox="1"/>
          <p:nvPr/>
        </p:nvSpPr>
        <p:spPr>
          <a:xfrm>
            <a:off x="4293168" y="1340388"/>
            <a:ext cx="10527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7B1A6630-12F4-58B5-D0EC-F88867F28C19}"/>
              </a:ext>
            </a:extLst>
          </p:cNvPr>
          <p:cNvSpPr txBox="1"/>
          <p:nvPr/>
        </p:nvSpPr>
        <p:spPr>
          <a:xfrm>
            <a:off x="4293168" y="5087407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7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91FCF938-BC51-0496-2AC5-8C7FD1F91B50}"/>
              </a:ext>
            </a:extLst>
          </p:cNvPr>
          <p:cNvSpPr txBox="1"/>
          <p:nvPr/>
        </p:nvSpPr>
        <p:spPr>
          <a:xfrm>
            <a:off x="4293168" y="5759144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1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381793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0</Words>
  <Application>Microsoft Office PowerPoint</Application>
  <PresentationFormat>宽屏</PresentationFormat>
  <Paragraphs>2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周 婷</dc:creator>
  <cp:lastModifiedBy>周 婷</cp:lastModifiedBy>
  <cp:revision>2</cp:revision>
  <dcterms:created xsi:type="dcterms:W3CDTF">2023-01-27T03:01:08Z</dcterms:created>
  <dcterms:modified xsi:type="dcterms:W3CDTF">2023-01-27T06:01:10Z</dcterms:modified>
</cp:coreProperties>
</file>